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29.wmf" ContentType="image/x-wmf"/>
  <Override PartName="/ppt/media/image10.wmf" ContentType="image/x-wmf"/>
  <Override PartName="/ppt/media/image5.wmf" ContentType="image/x-wmf"/>
  <Override PartName="/ppt/media/image28.wmf" ContentType="image/x-wmf"/>
  <Override PartName="/ppt/media/image4.wmf" ContentType="image/x-wmf"/>
  <Override PartName="/ppt/media/image27.wmf" ContentType="image/x-wmf"/>
  <Override PartName="/ppt/media/image3.wmf" ContentType="image/x-wmf"/>
  <Override PartName="/ppt/media/image26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4.wmf" ContentType="image/x-wmf"/>
  <Override PartName="/ppt/media/image2.wmf" ContentType="image/x-wmf"/>
  <Override PartName="/ppt/media/image25.wmf" ContentType="image/x-wmf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3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4.xml" ContentType="application/vnd.openxmlformats-officedocument.presentationml.slide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27.xml.rels" ContentType="application/vnd.openxmlformats-package.relationships+xml"/>
  <Override PartName="/ppt/slides/_rels/slide8.xml.rels" ContentType="application/vnd.openxmlformats-package.relationships+xml"/>
  <Override PartName="/ppt/slides/_rels/slide21.xml.rels" ContentType="application/vnd.openxmlformats-package.relationships+xml"/>
  <Override PartName="/ppt/slides/_rels/slide2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7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7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9.xml.rels" ContentType="application/vnd.openxmlformats-package.relationships+xml"/>
  <Override PartName="/ppt/slides/_rels/slide3.xml.rels" ContentType="application/vnd.openxmlformats-package.relationships+xml"/>
  <Override PartName="/ppt/slides/_rels/slide28.xml.rels" ContentType="application/vnd.openxmlformats-package.relationships+xml"/>
  <Override PartName="/ppt/slides/_rels/slide22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slide30.xml" ContentType="application/vnd.openxmlformats-officedocument.presentationml.slide+xml"/>
  <Override PartName="/ppt/slides/slide5.xml" ContentType="application/vnd.openxmlformats-officedocument.presentationml.slide+xml"/>
  <Override PartName="/ppt/slides/slide31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05324-ADE0-4171-84C3-366B271FA6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D2104-8AC5-4F4B-B671-53307F6216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C87B2-E828-4A68-A75B-7C65667F21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0508F-1554-4AD0-A41B-84F08231E6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D0EF2-18F1-47ED-AD8F-7D00FECF25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B95ED-3976-43BF-B6AB-93A44420B6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853B2-DED0-4255-9F9B-0385223213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77CAD-9882-404D-914E-F9BC508F20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8C330-AA96-4CD4-B662-32E2B5F32C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5128D-5972-48F5-A5CB-4E153AE4F1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FE77F-B443-4600-B5C6-DA7C341567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1ABCC-43D2-46FC-A620-B0D4745D37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15E236-E64B-48B8-B55C-5BFA6837E926}" type="slidenum">
              <a:rPr b="0" lang="da-DK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2.wmf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3.wmf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6.wmf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7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44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  <a:ea typeface="宋体"/>
              </a:rPr>
              <a:t>   </a:t>
            </a:r>
            <a:r>
              <a:rPr b="1" lang="en-US" sz="32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3:</a:t>
            </a: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宋体"/>
              </a:rPr>
              <a:t> The figures of the heritability estimates of the SNPs in LASSO analysis for 29 investigated conformation traits </a:t>
            </a: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with thresholds ascertained with 1,000 permutations </a:t>
            </a: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宋体"/>
              </a:rPr>
              <a:t>. 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1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  <a:ea typeface="宋体"/>
              </a:rPr>
              <a:t>Figure legend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394920" y="1557360"/>
            <a:ext cx="8435880" cy="35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5880" indent="0">
              <a:lnSpc>
                <a:spcPct val="12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宋体"/>
              </a:rPr>
              <a:t>The figures of the heritability estimates of the SNPs in LASSO analysis for 29 investigated conformation traits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with thresholds ascertained with 1,000 permutations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宋体"/>
              </a:rPr>
              <a:t>.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</a:rPr>
              <a:t>Five hundred SNPs against the heritability of 29 traits were plotted. </a:t>
            </a: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宋体"/>
              </a:rPr>
              <a:t>The dotted line is the thresholds, which was ascertained with 1,000 permutations.   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marL="335880" indent="0">
              <a:lnSpc>
                <a:spcPct val="120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1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1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1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1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1190520" y="58680"/>
            <a:ext cx="6762960" cy="674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6T12:22:09Z</dcterms:created>
  <dc:creator>Xiaoping Wu</dc:creator>
  <dc:description/>
  <dc:language>en-US</dc:language>
  <cp:lastModifiedBy>User</cp:lastModifiedBy>
  <dcterms:modified xsi:type="dcterms:W3CDTF">2013-10-06T08:42:59Z</dcterms:modified>
  <cp:revision>27</cp:revision>
  <dc:subject/>
  <dc:title>PowerPoint Presentation</dc:title>
</cp:coreProperties>
</file>